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928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984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17280" y="744120"/>
            <a:ext cx="4962600" cy="3722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71600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984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9840" y="942984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F5FB973-D2F1-4495-B010-8603EE100E5B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PlaceHolder 1"/>
          <p:cNvSpPr>
            <a:spLocks noGrp="1"/>
          </p:cNvSpPr>
          <p:nvPr>
            <p:ph type="sldImg"/>
          </p:nvPr>
        </p:nvSpPr>
        <p:spPr>
          <a:xfrm>
            <a:off x="917640" y="744480"/>
            <a:ext cx="4962600" cy="3722760"/>
          </a:xfrm>
          <a:prstGeom prst="rect">
            <a:avLst/>
          </a:prstGeom>
          <a:ln w="0">
            <a:noFill/>
          </a:ln>
        </p:spPr>
      </p:sp>
      <p:sp>
        <p:nvSpPr>
          <p:cNvPr id="53" name="PlaceHolder 2"/>
          <p:cNvSpPr>
            <a:spLocks noGrp="1"/>
          </p:cNvSpPr>
          <p:nvPr>
            <p:ph type="body"/>
          </p:nvPr>
        </p:nvSpPr>
        <p:spPr>
          <a:xfrm>
            <a:off x="679320" y="471600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Additional Figure 1:  Hazard ratios of ER-positive and ER-negative tumors for increased BMI</a:t>
            </a:r>
            <a:r>
              <a:rPr b="1" lang="en-US" sz="1200" spc="-1" strike="noStrike" baseline="30000">
                <a:solidFill>
                  <a:srgbClr val="000000"/>
                </a:solidFill>
                <a:latin typeface="Calibri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across 5-year age-bands.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All models are for a 5 kg/m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increase in BMI and were stratified by age at recruitment and study center. Hazard ratio estimates are shown for all women and HRT never users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Slide Number Placeholder 3"/>
          <p:cNvSpPr/>
          <p:nvPr/>
        </p:nvSpPr>
        <p:spPr>
          <a:xfrm>
            <a:off x="3849840" y="9429840"/>
            <a:ext cx="2946240" cy="4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9505154-D82F-4AC4-B820-9FD19AE0CAD4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CC6E25-CE1B-4F85-BF0D-45BFBCA6265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5AFF95-7C99-49D9-B045-20A656E201B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306E9E-EC72-41A7-BECC-4584B7CB07A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2FC0A0-5C59-4754-8374-E595A1F218B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56AE5D-76F4-47BD-9C6B-73EFF72C094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AA7A8A-4C29-4556-90EC-182C505FC5A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985261-8995-4AB0-8EF1-27C719D8DC1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074912-3518-4978-B5CE-001A3F7EE0F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FAFDC0-A9D5-490A-A3B8-8440D0BF962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B9F81C-C7E9-4FCC-8F45-CAD5C5C7C2E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E25BB4-209F-470A-A11B-8BB42B0F606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68B363-D0A2-4CFC-B096-FB9F586445C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60484D2-3337-418D-A16D-A68850DC28D4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5"/>
          <p:cNvSpPr/>
          <p:nvPr/>
        </p:nvSpPr>
        <p:spPr>
          <a:xfrm>
            <a:off x="144360" y="1674720"/>
            <a:ext cx="8926560" cy="38210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2"/>
          <p:cNvSpPr/>
          <p:nvPr/>
        </p:nvSpPr>
        <p:spPr>
          <a:xfrm>
            <a:off x="412920" y="4903920"/>
            <a:ext cx="84470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Figure s1 Hazard ratios of ER-positive and ER-negative tumors for increased BMI</a:t>
            </a:r>
            <a:r>
              <a:rPr b="1" lang="en-US" sz="1000" spc="-1" strike="noStrike" baseline="30000">
                <a:solidFill>
                  <a:srgbClr val="000000"/>
                </a:solidFill>
                <a:latin typeface="Calibri"/>
              </a:rPr>
              <a:t> </a:t>
            </a: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across 5-year age-bands. 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All models are for a 5 kg/m</a:t>
            </a:r>
            <a:r>
              <a:rPr b="0" lang="en-US" sz="1000" spc="-1" strike="noStrike" baseline="30000">
                <a:solidFill>
                  <a:srgbClr val="000000"/>
                </a:solidFill>
                <a:latin typeface="Calibri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increase in BMI and were stratified by age at recruitment and study center. Hazard ratio estimates are shown for all women and HRT never users.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0" name="Chart 7" descr=""/>
          <p:cNvPicPr/>
          <p:nvPr/>
        </p:nvPicPr>
        <p:blipFill>
          <a:blip r:embed="rId1"/>
          <a:stretch/>
        </p:blipFill>
        <p:spPr>
          <a:xfrm>
            <a:off x="285840" y="2060640"/>
            <a:ext cx="5005440" cy="2736720"/>
          </a:xfrm>
          <a:prstGeom prst="rect">
            <a:avLst/>
          </a:prstGeom>
          <a:ln w="0">
            <a:noFill/>
          </a:ln>
        </p:spPr>
      </p:pic>
      <p:pic>
        <p:nvPicPr>
          <p:cNvPr id="51" name="Chart 8" descr=""/>
          <p:cNvPicPr/>
          <p:nvPr/>
        </p:nvPicPr>
        <p:blipFill>
          <a:blip r:embed="rId2"/>
          <a:stretch/>
        </p:blipFill>
        <p:spPr>
          <a:xfrm>
            <a:off x="4059360" y="2066760"/>
            <a:ext cx="5005440" cy="2749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2-08T11:43:57Z</dcterms:created>
  <dc:creator>James, Rebecca</dc:creator>
  <dc:description/>
  <dc:language>en-US</dc:language>
  <cp:lastModifiedBy>Rebecca Ritte</cp:lastModifiedBy>
  <cp:lastPrinted>2011-12-13T11:51:43Z</cp:lastPrinted>
  <dcterms:modified xsi:type="dcterms:W3CDTF">2012-05-10T09:09:22Z</dcterms:modified>
  <cp:revision>45</cp:revision>
  <dc:subject/>
  <dc:title>PowerPoint Presentation</dc:title>
</cp:coreProperties>
</file>